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62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567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851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618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131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151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508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982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318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999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557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159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80826-4726-4DF8-B85B-ABF4853BE454}" type="datetimeFigureOut">
              <a:rPr lang="en-US" smtClean="0"/>
              <a:t>12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DFB05F-F1D5-42AA-A9C6-ECCED566F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741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277628" y="1188328"/>
            <a:ext cx="6123034" cy="3307472"/>
            <a:chOff x="1277628" y="914150"/>
            <a:chExt cx="6123034" cy="330747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977"/>
            <a:stretch/>
          </p:blipFill>
          <p:spPr bwMode="auto">
            <a:xfrm rot="16200000">
              <a:off x="1533510" y="675606"/>
              <a:ext cx="1554862" cy="20666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862"/>
            <a:stretch/>
          </p:blipFill>
          <p:spPr bwMode="auto">
            <a:xfrm rot="16200000">
              <a:off x="3605118" y="679173"/>
              <a:ext cx="1554860" cy="20594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5572143" y="676009"/>
              <a:ext cx="1573286" cy="20495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516920" y="2351508"/>
              <a:ext cx="1596589" cy="2075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3558236" y="2367564"/>
              <a:ext cx="1648624" cy="20594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5549738" y="2336468"/>
              <a:ext cx="1635187" cy="20666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1965124"/>
              </p:ext>
            </p:extLst>
          </p:nvPr>
        </p:nvGraphicFramePr>
        <p:xfrm>
          <a:off x="1371601" y="4572000"/>
          <a:ext cx="6029324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68264"/>
                <a:gridCol w="797866"/>
                <a:gridCol w="725332"/>
                <a:gridCol w="725332"/>
                <a:gridCol w="725332"/>
                <a:gridCol w="725332"/>
                <a:gridCol w="661866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DZNep (</a:t>
                      </a:r>
                      <a:r>
                        <a:rPr lang="en-US" sz="1400" dirty="0" err="1" smtClean="0"/>
                        <a:t>uM</a:t>
                      </a:r>
                      <a:r>
                        <a:rPr lang="en-US" sz="1400" dirty="0" smtClean="0"/>
                        <a:t>)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.5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</a:t>
                      </a:r>
                      <a:endParaRPr lang="en-US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G1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4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8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9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0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1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6%</a:t>
                      </a:r>
                      <a:endParaRPr lang="en-US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S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2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0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8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9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5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5%</a:t>
                      </a:r>
                      <a:endParaRPr lang="en-US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G2 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2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3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0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3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8%</a:t>
                      </a:r>
                      <a:endParaRPr lang="en-US" sz="14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913686" y="582534"/>
            <a:ext cx="7221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1. Cell cycle analyses of S462 cells treated with DZNep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1143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1716848" y="2447103"/>
            <a:ext cx="1683972" cy="22146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679358" y="759041"/>
            <a:ext cx="1730375" cy="21934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822006" y="740095"/>
            <a:ext cx="1730375" cy="22313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6016927" y="750208"/>
            <a:ext cx="1718270" cy="21990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853497" y="2444639"/>
            <a:ext cx="1703952" cy="22113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1046612"/>
              </p:ext>
            </p:extLst>
          </p:nvPr>
        </p:nvGraphicFramePr>
        <p:xfrm>
          <a:off x="1743076" y="4572000"/>
          <a:ext cx="6029324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68264"/>
                <a:gridCol w="797866"/>
                <a:gridCol w="725332"/>
                <a:gridCol w="725332"/>
                <a:gridCol w="725332"/>
                <a:gridCol w="725332"/>
                <a:gridCol w="661866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DZNep (</a:t>
                      </a:r>
                      <a:r>
                        <a:rPr lang="en-US" sz="1400" dirty="0" err="1" smtClean="0"/>
                        <a:t>uM</a:t>
                      </a:r>
                      <a:r>
                        <a:rPr lang="en-US" sz="1400" dirty="0" smtClean="0"/>
                        <a:t>)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.5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</a:t>
                      </a:r>
                      <a:endParaRPr lang="en-US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G1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3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9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1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4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4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2%</a:t>
                      </a:r>
                      <a:endParaRPr lang="en-US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S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2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7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3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2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0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1%</a:t>
                      </a:r>
                      <a:endParaRPr lang="en-US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G2 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%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%</a:t>
                      </a:r>
                      <a:endParaRPr lang="en-US" sz="1400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6040492" y="2461000"/>
            <a:ext cx="1711929" cy="2170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913686" y="582534"/>
            <a:ext cx="78543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2. Cell cycle analyses of MPNST724 cells treated with DZNep.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3074352" y="1403642"/>
            <a:ext cx="5373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DZNep</a:t>
            </a:r>
          </a:p>
          <a:p>
            <a:r>
              <a:rPr lang="en-US" sz="1000" dirty="0" smtClean="0"/>
              <a:t>0 </a:t>
            </a:r>
            <a:r>
              <a:rPr lang="en-US" sz="1000" dirty="0" err="1" smtClean="0"/>
              <a:t>uM</a:t>
            </a:r>
            <a:endParaRPr lang="en-US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5237843" y="1405784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DZNep</a:t>
            </a:r>
          </a:p>
          <a:p>
            <a:r>
              <a:rPr lang="en-US" sz="1000" dirty="0" smtClean="0"/>
              <a:t>0.5 </a:t>
            </a:r>
            <a:r>
              <a:rPr lang="en-US" sz="1000" dirty="0" err="1" smtClean="0"/>
              <a:t>uM</a:t>
            </a:r>
            <a:endParaRPr lang="en-US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7391400" y="1396524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DZNep</a:t>
            </a:r>
          </a:p>
          <a:p>
            <a:r>
              <a:rPr lang="en-US" sz="1000" dirty="0"/>
              <a:t>1</a:t>
            </a:r>
            <a:r>
              <a:rPr lang="en-US" sz="1000" dirty="0" smtClean="0"/>
              <a:t> </a:t>
            </a:r>
            <a:r>
              <a:rPr lang="en-US" sz="1000" dirty="0" err="1" smtClean="0"/>
              <a:t>uM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3087151" y="3181290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DZNep</a:t>
            </a:r>
          </a:p>
          <a:p>
            <a:r>
              <a:rPr lang="en-US" sz="1000" dirty="0" smtClean="0"/>
              <a:t>2 </a:t>
            </a:r>
            <a:r>
              <a:rPr lang="en-US" sz="1000" dirty="0" err="1" smtClean="0"/>
              <a:t>uM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5223601" y="3181290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DZNep</a:t>
            </a:r>
          </a:p>
          <a:p>
            <a:r>
              <a:rPr lang="en-US" sz="1000" dirty="0" smtClean="0"/>
              <a:t>5 </a:t>
            </a:r>
            <a:r>
              <a:rPr lang="en-US" sz="1000" dirty="0" err="1" smtClean="0"/>
              <a:t>uM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7388568" y="3181290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DZNep</a:t>
            </a:r>
          </a:p>
          <a:p>
            <a:r>
              <a:rPr lang="en-US" sz="1000" dirty="0" smtClean="0"/>
              <a:t>10 </a:t>
            </a:r>
            <a:r>
              <a:rPr lang="en-US" sz="1000" dirty="0" err="1" smtClean="0"/>
              <a:t>uM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459094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144</Words>
  <Application>Microsoft Office PowerPoint</Application>
  <PresentationFormat>On-screen Show (4:3)</PresentationFormat>
  <Paragraphs>7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Pingyu</dc:creator>
  <cp:lastModifiedBy>Zhang,Pingyu</cp:lastModifiedBy>
  <cp:revision>10</cp:revision>
  <dcterms:created xsi:type="dcterms:W3CDTF">2014-12-17T16:15:40Z</dcterms:created>
  <dcterms:modified xsi:type="dcterms:W3CDTF">2014-12-17T17:49:23Z</dcterms:modified>
</cp:coreProperties>
</file>